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243"/>
    <p:restoredTop sz="97585"/>
  </p:normalViewPr>
  <p:slideViewPr>
    <p:cSldViewPr snapToGrid="0">
      <p:cViewPr varScale="1">
        <p:scale>
          <a:sx n="104" d="100"/>
          <a:sy n="104" d="100"/>
        </p:scale>
        <p:origin x="232" y="7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7CF3BE-0850-38EB-CD02-577B04CD9D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5596444-0E49-53A6-41CA-33F17A14A5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785196-4D0F-4EA9-18C5-C9C09FAB0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78A78D-2903-5ED4-D36E-537F2EB2A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5CE000-6989-4B6A-5012-21A74D3B7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42776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449ED3-CCBD-618C-B85C-2C6F5E64D5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8A09721-C98A-B0D3-3FF9-FC05BCD5F6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26A294B-5E90-DE60-9E07-EF1C0CA43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406663-5084-B4A0-EE6D-8A547BDDA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96DF8F-FA77-3212-0708-4BE704AE4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36938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B081E53-AF77-8A0E-9B3A-77EDCC7DA8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50DD2CB-4C64-5B3F-1AC8-ECBCADF4E2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0511C4-0553-5BCC-8B8A-5E2C34D22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4A7F0F-9E76-334E-DA73-3544E6BA1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E3C9C0-6F67-8EC8-C287-086E098EF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18230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31FC23-E042-2EB6-CD54-4BC4415505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CBC6148-78D7-7D73-AC89-89C9BEC969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4CFD80-EC2C-E32F-0FE1-F5400892C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3118C8-D290-B898-F8E4-A1E57D39A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1A1FE6-EDA7-7134-0033-429ABD9BA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6920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F64335-D58E-65F7-7F02-532C0F02C1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58C05A-9A05-CDDD-0A5C-00D10A6556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1A6E78-B5D4-2EC8-66D7-C5F2B332A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E0B535D-7651-756C-C4F3-8D9662681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3CD126A-98A8-D066-83EF-4FDBF4647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79668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9BDD25-74ED-97DA-D2CA-B91990FBEA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A910B42-4A41-3591-C0D3-F808056F05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D120D0E-77A3-C7F8-9921-45C9E18750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3C5FDE9-E0AC-3812-A6D2-DF7CFB8E7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DB9EDE-5FE6-00F6-398A-F31F419B2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961319D-0D14-093C-23F0-FBC9DECB3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46244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C4D8C2-9BD0-F039-A7BA-E73BED1959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1FB6CBC-491C-AE0E-5879-133173AF21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5CB7338-3F2D-EC72-1592-F0A77B43FB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9C793B0-1E1B-FF3C-2CCA-0390039431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975C758-3A3D-DD5A-D174-453DD36DCF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CB6F3C5-D399-8AD8-6DD3-CD945634A0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A81A358-C4C4-9BEF-C61E-62766AC4D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87D0C83-8FA2-B752-3FE0-9E2353DA0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80742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440868-28EA-925B-468A-53386BE2B7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6CC66A7-A666-797E-1B8F-425AC9B3D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5E15D13-754B-119F-6340-1DCB87FBA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3BED036-72B1-D874-3486-E66DC341E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0007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299A673-C7A7-C718-1384-BFECB024F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DE1E23C-AD62-49C6-C81E-F805FE29A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1CA084E-264F-77D2-24D3-37DB09F89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73027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E7C083-8E2E-D0BE-10F6-8C57B964D5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1FC3FC1-55BB-8CC8-9B59-C3B94FC091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08C9EA0-EA35-BD6E-B4C5-717AB3B518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ECB04A-CD56-7310-BB58-4A354F16E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A1F1ADF-B870-60CF-DFE3-8050E4FAC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D72D49D-FECC-079D-5296-0B18A8CBB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81031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E4D84C-5021-F532-0209-112D59C778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95AF45A-3628-DD49-A624-EB7BF45F49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7870EFA-692D-A2CD-3858-C628D8CC37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23FDCB4-11A7-1ABC-9E01-94E273793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E0E4C98-330D-3CED-D1B8-D37B522E8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10816FF-DFB2-B6CC-E7AC-B214C8DF4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77873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4427FDF-BF66-26D7-9A78-1170FDAF53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4155EE2-D748-EB44-5DA9-43FDDDA394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BD6B0E-2D93-2564-19F8-B8230DAC92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AE14C4-1930-FA49-850D-55E090D3DD40}" type="datetimeFigureOut">
              <a:rPr kumimoji="1" lang="zh-CN" altLang="en-US" smtClean="0"/>
              <a:t>2024/7/2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F2BA24-BEAE-61F7-0E89-1A3D22334B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FE926F-3CE2-E55E-4411-4656072F14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62549F-E833-F44D-B238-D82843E39FF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8055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>
            <a:extLst>
              <a:ext uri="{FF2B5EF4-FFF2-40B4-BE49-F238E27FC236}">
                <a16:creationId xmlns:a16="http://schemas.microsoft.com/office/drawing/2014/main" id="{DFDF2C29-0B01-675E-24E2-308E207CB3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16320" y="619211"/>
            <a:ext cx="4749800" cy="49276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1DAE6D3-A9E1-5CEF-7925-702A2CB049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529" t="8995" r="4836"/>
          <a:stretch/>
        </p:blipFill>
        <p:spPr>
          <a:xfrm>
            <a:off x="152400" y="-45034"/>
            <a:ext cx="7122160" cy="370011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04FFD17-CCB5-DB68-5BDE-82D60086E91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970" r="1185"/>
          <a:stretch/>
        </p:blipFill>
        <p:spPr>
          <a:xfrm>
            <a:off x="0" y="2990334"/>
            <a:ext cx="7680308" cy="3904438"/>
          </a:xfrm>
          <a:prstGeom prst="rect">
            <a:avLst/>
          </a:prstGeom>
        </p:spPr>
      </p:pic>
      <p:cxnSp>
        <p:nvCxnSpPr>
          <p:cNvPr id="11" name="直线箭头连接符 10">
            <a:extLst>
              <a:ext uri="{FF2B5EF4-FFF2-40B4-BE49-F238E27FC236}">
                <a16:creationId xmlns:a16="http://schemas.microsoft.com/office/drawing/2014/main" id="{7DCAE774-23DD-734D-5338-21BDCA7C0387}"/>
              </a:ext>
            </a:extLst>
          </p:cNvPr>
          <p:cNvCxnSpPr>
            <a:cxnSpLocks/>
          </p:cNvCxnSpPr>
          <p:nvPr/>
        </p:nvCxnSpPr>
        <p:spPr>
          <a:xfrm flipH="1" flipV="1">
            <a:off x="2669060" y="2113943"/>
            <a:ext cx="494270" cy="159699"/>
          </a:xfrm>
          <a:prstGeom prst="straightConnector1">
            <a:avLst/>
          </a:prstGeom>
          <a:ln w="254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线箭头连接符 12">
            <a:extLst>
              <a:ext uri="{FF2B5EF4-FFF2-40B4-BE49-F238E27FC236}">
                <a16:creationId xmlns:a16="http://schemas.microsoft.com/office/drawing/2014/main" id="{48371B02-9D29-A81D-A48F-38B6E7B09514}"/>
              </a:ext>
            </a:extLst>
          </p:cNvPr>
          <p:cNvCxnSpPr>
            <a:cxnSpLocks/>
          </p:cNvCxnSpPr>
          <p:nvPr/>
        </p:nvCxnSpPr>
        <p:spPr>
          <a:xfrm flipH="1" flipV="1">
            <a:off x="6479060" y="2193792"/>
            <a:ext cx="494270" cy="159699"/>
          </a:xfrm>
          <a:prstGeom prst="straightConnector1">
            <a:avLst/>
          </a:prstGeom>
          <a:ln w="254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线箭头连接符 13">
            <a:extLst>
              <a:ext uri="{FF2B5EF4-FFF2-40B4-BE49-F238E27FC236}">
                <a16:creationId xmlns:a16="http://schemas.microsoft.com/office/drawing/2014/main" id="{99210935-9703-FD35-AF68-535CBF0C26B7}"/>
              </a:ext>
            </a:extLst>
          </p:cNvPr>
          <p:cNvCxnSpPr>
            <a:cxnSpLocks/>
          </p:cNvCxnSpPr>
          <p:nvPr/>
        </p:nvCxnSpPr>
        <p:spPr>
          <a:xfrm flipH="1" flipV="1">
            <a:off x="10643288" y="3749154"/>
            <a:ext cx="494270" cy="159699"/>
          </a:xfrm>
          <a:prstGeom prst="straightConnector1">
            <a:avLst/>
          </a:prstGeom>
          <a:ln w="254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44DF79C2-997E-04FF-3780-C321BF0E20D8}"/>
              </a:ext>
            </a:extLst>
          </p:cNvPr>
          <p:cNvSpPr txBox="1"/>
          <p:nvPr/>
        </p:nvSpPr>
        <p:spPr>
          <a:xfrm>
            <a:off x="444843" y="4572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602569A-F07A-EB4B-78B1-258B1ED7C794}"/>
              </a:ext>
            </a:extLst>
          </p:cNvPr>
          <p:cNvSpPr txBox="1"/>
          <p:nvPr/>
        </p:nvSpPr>
        <p:spPr>
          <a:xfrm>
            <a:off x="438431" y="301298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DDF77D2-7375-0BFB-EBEA-8E264E9C1D4D}"/>
              </a:ext>
            </a:extLst>
          </p:cNvPr>
          <p:cNvSpPr txBox="1"/>
          <p:nvPr/>
        </p:nvSpPr>
        <p:spPr>
          <a:xfrm>
            <a:off x="7628923" y="110331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87242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A44331-0942-93CA-3F9B-D7AFE60902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4132E04-689C-0812-99A0-75E9B02F02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kumimoji="1" lang="en-US" altLang="zh-CN" dirty="0"/>
              <a:t>Figure legend</a:t>
            </a:r>
          </a:p>
          <a:p>
            <a:pPr marL="0" indent="0">
              <a:buNone/>
            </a:pPr>
            <a:endParaRPr kumimoji="1" lang="en-US" altLang="zh-CN" dirty="0"/>
          </a:p>
          <a:p>
            <a:pPr marL="0" indent="0">
              <a:buNone/>
            </a:pPr>
            <a:r>
              <a:rPr kumimoji="1"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Structural comparisons of </a:t>
            </a:r>
            <a:r>
              <a:rPr kumimoji="1" lang="en-US" altLang="zh-CN" sz="1800" b="1" dirty="0" err="1">
                <a:latin typeface="Arial" panose="020B0604020202020204" pitchFamily="34" charset="0"/>
                <a:cs typeface="Arial" panose="020B0604020202020204" pitchFamily="34" charset="0"/>
              </a:rPr>
              <a:t>mCRP</a:t>
            </a:r>
            <a:r>
              <a:rPr kumimoji="1"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kumimoji="1" lang="en-US" altLang="zh-CN" sz="1800" b="1" dirty="0" err="1">
                <a:latin typeface="Arial" panose="020B0604020202020204" pitchFamily="34" charset="0"/>
                <a:cs typeface="Arial" panose="020B0604020202020204" pitchFamily="34" charset="0"/>
              </a:rPr>
              <a:t>hCRP</a:t>
            </a:r>
            <a:r>
              <a:rPr kumimoji="1"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pPr marL="342900" indent="-342900">
              <a:buAutoNum type="alphaLcPeriod"/>
            </a:pP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ibbons diagrams showing the structures of </a:t>
            </a:r>
            <a:r>
              <a:rPr kumimoji="1"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mCRP</a:t>
            </a: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kumimoji="1"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hCRP</a:t>
            </a: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. The bound PG and residues involved in calcium binding and around the PG binding pocket are shown in sticks with the O, P and N atoms colored red, orange and blue, respectively. The C atoms in the residues are colored dark green in </a:t>
            </a:r>
            <a:r>
              <a:rPr kumimoji="1"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mCRP</a:t>
            </a: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and brown in </a:t>
            </a:r>
            <a:r>
              <a:rPr kumimoji="1"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hCRP</a:t>
            </a: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. The red arrows indicate the loop68-72, in which residue 71 flips in </a:t>
            </a:r>
            <a:r>
              <a:rPr kumimoji="1"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mCRP</a:t>
            </a: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compared to that in </a:t>
            </a:r>
            <a:r>
              <a:rPr kumimoji="1"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hCRP</a:t>
            </a: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342900" indent="-342900">
              <a:buAutoNum type="alphaLcPeriod"/>
            </a:pP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Surface rendered representation showing the binding pocket of PG. The surface is colored according to the surface electrostatic potential. The bound PG is shown in stick. </a:t>
            </a:r>
          </a:p>
          <a:p>
            <a:pPr marL="342900" indent="-342900">
              <a:buAutoNum type="alphaLcPeriod"/>
            </a:pP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Ribbons diagrams showing the superimposed structures of </a:t>
            </a:r>
            <a:r>
              <a:rPr kumimoji="1"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mCRP</a:t>
            </a: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kumimoji="1"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hCRP</a:t>
            </a:r>
            <a:r>
              <a:rPr kumimoji="1"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. The red arrow indicates the flipped loop.</a:t>
            </a:r>
          </a:p>
          <a:p>
            <a:pPr marL="342900" indent="-342900">
              <a:buAutoNum type="alphaLcPeriod"/>
            </a:pPr>
            <a:endParaRPr kumimoji="1"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7525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43</Words>
  <Application>Microsoft Macintosh PowerPoint</Application>
  <PresentationFormat>宽屏</PresentationFormat>
  <Paragraphs>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Microsoft Office User</cp:lastModifiedBy>
  <cp:revision>3</cp:revision>
  <dcterms:created xsi:type="dcterms:W3CDTF">2024-07-27T15:16:08Z</dcterms:created>
  <dcterms:modified xsi:type="dcterms:W3CDTF">2024-07-27T15:33:56Z</dcterms:modified>
</cp:coreProperties>
</file>